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6"/>
  </p:notesMasterIdLst>
  <p:sldIdLst>
    <p:sldId id="308" r:id="rId2"/>
    <p:sldId id="287" r:id="rId3"/>
    <p:sldId id="289" r:id="rId4"/>
    <p:sldId id="294" r:id="rId5"/>
    <p:sldId id="299" r:id="rId6"/>
    <p:sldId id="301" r:id="rId7"/>
    <p:sldId id="306" r:id="rId8"/>
    <p:sldId id="309" r:id="rId9"/>
    <p:sldId id="310" r:id="rId10"/>
    <p:sldId id="314" r:id="rId11"/>
    <p:sldId id="317" r:id="rId12"/>
    <p:sldId id="322" r:id="rId13"/>
    <p:sldId id="326" r:id="rId14"/>
    <p:sldId id="329" r:id="rId15"/>
    <p:sldId id="331" r:id="rId16"/>
    <p:sldId id="332" r:id="rId17"/>
    <p:sldId id="335" r:id="rId18"/>
    <p:sldId id="339" r:id="rId19"/>
    <p:sldId id="344" r:id="rId20"/>
    <p:sldId id="348" r:id="rId21"/>
    <p:sldId id="351" r:id="rId22"/>
    <p:sldId id="352" r:id="rId23"/>
    <p:sldId id="256" r:id="rId24"/>
    <p:sldId id="257" r:id="rId25"/>
    <p:sldId id="258" r:id="rId26"/>
    <p:sldId id="259" r:id="rId27"/>
    <p:sldId id="260" r:id="rId28"/>
    <p:sldId id="261" r:id="rId29"/>
    <p:sldId id="262" r:id="rId30"/>
    <p:sldId id="263" r:id="rId31"/>
    <p:sldId id="264" r:id="rId32"/>
    <p:sldId id="265" r:id="rId33"/>
    <p:sldId id="266" r:id="rId34"/>
    <p:sldId id="267" r:id="rId3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1" d="100"/>
          <a:sy n="81" d="100"/>
        </p:scale>
        <p:origin x="-834" y="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lt-L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DED161-B4DE-444B-BD6C-D623B46CF713}" type="datetimeFigureOut">
              <a:rPr lang="lt-LT" smtClean="0"/>
              <a:t>2019.08.27</a:t>
            </a:fld>
            <a:endParaRPr lang="lt-L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lt-L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lt-L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lt-L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D1A4AA-A476-4F85-970F-24F53DEC1FCA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2902364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png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7" Type="http://schemas.openxmlformats.org/officeDocument/2006/relationships/image" Target="../media/image63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4" Type="http://schemas.openxmlformats.org/officeDocument/2006/relationships/image" Target="../media/image60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3" Type="http://schemas.openxmlformats.org/officeDocument/2006/relationships/image" Target="../media/image65.png"/><Relationship Id="rId7" Type="http://schemas.openxmlformats.org/officeDocument/2006/relationships/image" Target="../media/image69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10" Type="http://schemas.openxmlformats.org/officeDocument/2006/relationships/image" Target="../media/image72.png"/><Relationship Id="rId4" Type="http://schemas.openxmlformats.org/officeDocument/2006/relationships/image" Target="../media/image66.png"/><Relationship Id="rId9" Type="http://schemas.openxmlformats.org/officeDocument/2006/relationships/image" Target="../media/image7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7" Type="http://schemas.openxmlformats.org/officeDocument/2006/relationships/image" Target="../media/image84.png"/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png"/><Relationship Id="rId5" Type="http://schemas.openxmlformats.org/officeDocument/2006/relationships/image" Target="../media/image82.png"/><Relationship Id="rId4" Type="http://schemas.openxmlformats.org/officeDocument/2006/relationships/image" Target="../media/image81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png"/><Relationship Id="rId3" Type="http://schemas.openxmlformats.org/officeDocument/2006/relationships/image" Target="../media/image86.png"/><Relationship Id="rId7" Type="http://schemas.openxmlformats.org/officeDocument/2006/relationships/image" Target="../media/image90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9.png"/><Relationship Id="rId5" Type="http://schemas.openxmlformats.org/officeDocument/2006/relationships/image" Target="../media/image88.png"/><Relationship Id="rId10" Type="http://schemas.openxmlformats.org/officeDocument/2006/relationships/image" Target="../media/image93.png"/><Relationship Id="rId4" Type="http://schemas.openxmlformats.org/officeDocument/2006/relationships/image" Target="../media/image87.png"/><Relationship Id="rId9" Type="http://schemas.openxmlformats.org/officeDocument/2006/relationships/image" Target="../media/image92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7" Type="http://schemas.openxmlformats.org/officeDocument/2006/relationships/image" Target="../media/image99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8.png"/><Relationship Id="rId5" Type="http://schemas.openxmlformats.org/officeDocument/2006/relationships/image" Target="../media/image97.png"/><Relationship Id="rId4" Type="http://schemas.openxmlformats.org/officeDocument/2006/relationships/image" Target="../media/image9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7" Type="http://schemas.openxmlformats.org/officeDocument/2006/relationships/image" Target="../media/image105.png"/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4.png"/><Relationship Id="rId5" Type="http://schemas.openxmlformats.org/officeDocument/2006/relationships/image" Target="../media/image103.png"/><Relationship Id="rId4" Type="http://schemas.openxmlformats.org/officeDocument/2006/relationships/image" Target="../media/image102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png"/><Relationship Id="rId3" Type="http://schemas.openxmlformats.org/officeDocument/2006/relationships/image" Target="../media/image107.png"/><Relationship Id="rId7" Type="http://schemas.openxmlformats.org/officeDocument/2006/relationships/image" Target="../media/image111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png"/><Relationship Id="rId5" Type="http://schemas.openxmlformats.org/officeDocument/2006/relationships/image" Target="../media/image109.png"/><Relationship Id="rId10" Type="http://schemas.openxmlformats.org/officeDocument/2006/relationships/image" Target="../media/image114.png"/><Relationship Id="rId4" Type="http://schemas.openxmlformats.org/officeDocument/2006/relationships/image" Target="../media/image108.png"/><Relationship Id="rId9" Type="http://schemas.openxmlformats.org/officeDocument/2006/relationships/image" Target="../media/image1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png"/><Relationship Id="rId7" Type="http://schemas.openxmlformats.org/officeDocument/2006/relationships/image" Target="../media/image120.png"/><Relationship Id="rId2" Type="http://schemas.openxmlformats.org/officeDocument/2006/relationships/image" Target="../media/image1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9.png"/><Relationship Id="rId5" Type="http://schemas.openxmlformats.org/officeDocument/2006/relationships/image" Target="../media/image118.png"/><Relationship Id="rId4" Type="http://schemas.openxmlformats.org/officeDocument/2006/relationships/image" Target="../media/image117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2.png"/><Relationship Id="rId7" Type="http://schemas.openxmlformats.org/officeDocument/2006/relationships/image" Target="../media/image126.png"/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5.png"/><Relationship Id="rId5" Type="http://schemas.openxmlformats.org/officeDocument/2006/relationships/image" Target="../media/image124.png"/><Relationship Id="rId4" Type="http://schemas.openxmlformats.org/officeDocument/2006/relationships/image" Target="../media/image123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jpeg"/><Relationship Id="rId2" Type="http://schemas.openxmlformats.org/officeDocument/2006/relationships/image" Target="../media/image12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9.jpe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1.jpeg"/><Relationship Id="rId2" Type="http://schemas.openxmlformats.org/officeDocument/2006/relationships/image" Target="../media/image13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2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4.jpeg"/><Relationship Id="rId2" Type="http://schemas.openxmlformats.org/officeDocument/2006/relationships/image" Target="../media/image133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5.jpe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7.jpeg"/><Relationship Id="rId2" Type="http://schemas.openxmlformats.org/officeDocument/2006/relationships/image" Target="../media/image136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8.jpe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0.jpeg"/><Relationship Id="rId2" Type="http://schemas.openxmlformats.org/officeDocument/2006/relationships/image" Target="../media/image13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1.jpe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3.jpeg"/><Relationship Id="rId2" Type="http://schemas.openxmlformats.org/officeDocument/2006/relationships/image" Target="../media/image14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4.jpe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6.jpeg"/><Relationship Id="rId2" Type="http://schemas.openxmlformats.org/officeDocument/2006/relationships/image" Target="../media/image14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9.jpeg"/><Relationship Id="rId2" Type="http://schemas.openxmlformats.org/officeDocument/2006/relationships/image" Target="../media/image148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0.jpe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2.jpeg"/><Relationship Id="rId2" Type="http://schemas.openxmlformats.org/officeDocument/2006/relationships/image" Target="../media/image15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3.jpe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5.jpeg"/><Relationship Id="rId2" Type="http://schemas.openxmlformats.org/officeDocument/2006/relationships/image" Target="../media/image154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6.jpe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8.jpeg"/><Relationship Id="rId2" Type="http://schemas.openxmlformats.org/officeDocument/2006/relationships/image" Target="../media/image15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9.jpe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1.jpeg"/><Relationship Id="rId2" Type="http://schemas.openxmlformats.org/officeDocument/2006/relationships/image" Target="../media/image16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10" Type="http://schemas.openxmlformats.org/officeDocument/2006/relationships/image" Target="../media/image51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00200" y="2590800"/>
            <a:ext cx="6096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lt-LT" dirty="0" smtClean="0"/>
              <a:t>NB4 cell death after HFIP and HFIP-free protocol amyloid treatmet for 24 and 48 hours</a:t>
            </a:r>
          </a:p>
          <a:p>
            <a:pPr algn="ctr"/>
            <a:r>
              <a:rPr lang="lt-LT" dirty="0" smtClean="0"/>
              <a:t>Fig 9</a:t>
            </a:r>
            <a:endParaRPr lang="lt-LT" dirty="0"/>
          </a:p>
        </p:txBody>
      </p:sp>
    </p:spTree>
    <p:extLst>
      <p:ext uri="{BB962C8B-B14F-4D97-AF65-F5344CB8AC3E}">
        <p14:creationId xmlns:p14="http://schemas.microsoft.com/office/powerpoint/2010/main" val="21150485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914399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600" y="91440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776287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349056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28600" y="349056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00600" y="3352453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4435028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67000" y="980728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81000" y="980728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76800" y="842615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667000" y="3578919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81000" y="3578919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76800" y="3440807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551594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02345" y="21207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21207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1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105400" y="179824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602345" y="242210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242210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105400" y="2389857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602345" y="4652558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04800" y="4652558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105400" y="4620308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0622343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73482" y="760086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355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771631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355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621973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73482" y="335690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335690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19073" y="321879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74437975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1046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662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1046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6628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90872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356711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356711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00600" y="342900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13524053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00200" y="2590800"/>
            <a:ext cx="6096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lt-LT" dirty="0" smtClean="0"/>
              <a:t>MCF-7 cell death after HFIP and HFIP-free protocol amyloid treatmet for 24 and 48 hours</a:t>
            </a:r>
          </a:p>
          <a:p>
            <a:pPr algn="ctr"/>
            <a:r>
              <a:rPr lang="lt-LT" dirty="0"/>
              <a:t>S4 Appendix. Fig </a:t>
            </a:r>
            <a:r>
              <a:rPr lang="lt-LT" dirty="0" smtClean="0"/>
              <a:t>S2</a:t>
            </a:r>
            <a:endParaRPr lang="lt-LT" dirty="0"/>
          </a:p>
        </p:txBody>
      </p:sp>
    </p:spTree>
    <p:extLst>
      <p:ext uri="{BB962C8B-B14F-4D97-AF65-F5344CB8AC3E}">
        <p14:creationId xmlns:p14="http://schemas.microsoft.com/office/powerpoint/2010/main" val="23647299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181600" y="140443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667000" y="172693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32617" y="172693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667000" y="2387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32617" y="2387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184048" y="2355582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667000" y="457785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32617" y="457785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184048" y="4545600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1070895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38400" y="60036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6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600" y="60960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462251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438400" y="335245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28600" y="335245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00600" y="321434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45363525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1046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1046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90872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3645023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3645023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00600" y="3506911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1801217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02345" y="10845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10845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953000" y="76200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602345" y="236746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236746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953000" y="2335212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602345" y="460792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04800" y="460792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4953000" y="4575675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3046097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90800" y="12735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600" y="12735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105400" y="95105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90800" y="23771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28600" y="23771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105400" y="2344882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590800" y="460425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228600" y="460425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105400" y="4572000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7308222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97482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97482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412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836712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357301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357301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789055" y="3434903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65073414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1046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48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" y="10468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48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90872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3573016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04800" y="3573016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00600" y="3434903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80030818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2447636"/>
            <a:ext cx="35823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Fluorescence analysis of cancer cells</a:t>
            </a:r>
          </a:p>
          <a:p>
            <a:pPr algn="ctr"/>
            <a:r>
              <a:rPr lang="lt-LT" dirty="0" smtClean="0"/>
              <a:t>Fig 10</a:t>
            </a:r>
            <a:endParaRPr lang="lt-LT" dirty="0"/>
          </a:p>
        </p:txBody>
      </p:sp>
    </p:spTree>
    <p:extLst>
      <p:ext uri="{BB962C8B-B14F-4D97-AF65-F5344CB8AC3E}">
        <p14:creationId xmlns:p14="http://schemas.microsoft.com/office/powerpoint/2010/main" val="27931733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8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600" y="582889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600" y="3639127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82728" y="1618032"/>
            <a:ext cx="1321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NB4 Control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33011699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639126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09842" y="1622230"/>
            <a:ext cx="867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NB4 4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255350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639126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51332" y="1652248"/>
            <a:ext cx="984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NB4 24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08169435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7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639126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51332" y="1652248"/>
            <a:ext cx="984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NB4 48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81464177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2195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9" y="3639127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36242" y="1652248"/>
            <a:ext cx="1414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A549 Control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3832022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7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9" y="3639126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63354" y="165224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A549 4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82767536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7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9" y="3634508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04844" y="1652248"/>
            <a:ext cx="1077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A549 24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1448737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785091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600" y="76200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953000" y="623887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341855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28600" y="341855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953000" y="3280445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31398419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7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639126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60750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04845" y="1636084"/>
            <a:ext cx="1077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A549 48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907258992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639126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671320" y="1652248"/>
            <a:ext cx="1544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MCF-7 Control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66710559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7" y="3639126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752" y="3639127"/>
            <a:ext cx="3363231" cy="252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02185" y="1652248"/>
            <a:ext cx="1090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MCF-7 4h</a:t>
            </a:r>
            <a:endParaRPr lang="lt-LT" dirty="0"/>
          </a:p>
        </p:txBody>
      </p:sp>
      <p:sp>
        <p:nvSpPr>
          <p:cNvPr id="7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8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9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042905125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7" y="3639126"/>
            <a:ext cx="3363231" cy="25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639126"/>
            <a:ext cx="3363231" cy="25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39924" y="1652248"/>
            <a:ext cx="1207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MCF-7 24h</a:t>
            </a:r>
            <a:endParaRPr lang="lt-LT" dirty="0"/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8729425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3639127"/>
            <a:ext cx="3363231" cy="252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9" y="3639127"/>
            <a:ext cx="3363231" cy="252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1598" y="576914"/>
            <a:ext cx="3363231" cy="252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708680" y="1652248"/>
            <a:ext cx="1207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t-LT" dirty="0" smtClean="0"/>
              <a:t>MCF-7 48h</a:t>
            </a:r>
            <a:endParaRPr lang="lt-LT" dirty="0"/>
          </a:p>
        </p:txBody>
      </p:sp>
      <p:sp>
        <p:nvSpPr>
          <p:cNvPr id="9" name="TextBox 2"/>
          <p:cNvSpPr txBox="1">
            <a:spLocks noChangeArrowheads="1"/>
          </p:cNvSpPr>
          <p:nvPr/>
        </p:nvSpPr>
        <p:spPr bwMode="auto">
          <a:xfrm>
            <a:off x="1860389" y="3362128"/>
            <a:ext cx="9039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 smtClean="0"/>
              <a:t>D</a:t>
            </a:r>
            <a:r>
              <a:rPr lang="en-US" altLang="en-US" sz="1200" dirty="0" smtClean="0"/>
              <a:t>API</a:t>
            </a:r>
            <a:r>
              <a:rPr lang="lt-LT" altLang="en-US" sz="1200" dirty="0" smtClean="0"/>
              <a:t>/</a:t>
            </a:r>
            <a:r>
              <a:rPr lang="en-US" altLang="en-US" sz="1200" dirty="0"/>
              <a:t>FAM</a:t>
            </a:r>
            <a:endParaRPr lang="lt-LT" altLang="en-US" sz="1200" dirty="0"/>
          </a:p>
        </p:txBody>
      </p:sp>
      <p:sp>
        <p:nvSpPr>
          <p:cNvPr id="10" name="TextBox 3"/>
          <p:cNvSpPr txBox="1">
            <a:spLocks noChangeArrowheads="1"/>
          </p:cNvSpPr>
          <p:nvPr/>
        </p:nvSpPr>
        <p:spPr bwMode="auto">
          <a:xfrm>
            <a:off x="6591345" y="299915"/>
            <a:ext cx="5437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lt-LT" altLang="en-US" sz="1200" dirty="0"/>
              <a:t>DAPI</a:t>
            </a:r>
          </a:p>
        </p:txBody>
      </p:sp>
      <p:sp>
        <p:nvSpPr>
          <p:cNvPr id="11" name="TextBox 4"/>
          <p:cNvSpPr txBox="1">
            <a:spLocks noChangeArrowheads="1"/>
          </p:cNvSpPr>
          <p:nvPr/>
        </p:nvSpPr>
        <p:spPr bwMode="auto">
          <a:xfrm>
            <a:off x="6612408" y="3362127"/>
            <a:ext cx="50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FAM</a:t>
            </a:r>
            <a:endParaRPr lang="lt-LT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787987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24382" y="53614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81000" y="53614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39803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24382" y="310991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81000" y="310991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00600" y="297180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6376430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4600" y="120396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600" y="120396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1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105400" y="88146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4600" y="227585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35527" y="227585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105400" y="2275855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514600" y="45004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235527" y="450043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105400" y="4468182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376418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67000" y="90011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57200" y="900112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76800" y="762000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667000" y="345106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57200" y="345106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76800" y="3312955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6705452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787312" y="87723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48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81000" y="87723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48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105400" y="739122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787312" y="350100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81000" y="3501007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105400" y="3362895"/>
            <a:ext cx="3810000" cy="237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5929844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00200" y="2590800"/>
            <a:ext cx="6096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lt-LT" dirty="0" smtClean="0"/>
              <a:t>A549 cell death after HFIP and HFIP-free protocol amyloid treatmet for 24 and 48 hours</a:t>
            </a:r>
          </a:p>
          <a:p>
            <a:pPr algn="ctr"/>
            <a:r>
              <a:rPr lang="lt-LT" dirty="0" smtClean="0"/>
              <a:t>S4 Appendix. Fig S1</a:t>
            </a:r>
            <a:endParaRPr lang="lt-LT" dirty="0"/>
          </a:p>
        </p:txBody>
      </p:sp>
    </p:spTree>
    <p:extLst>
      <p:ext uri="{BB962C8B-B14F-4D97-AF65-F5344CB8AC3E}">
        <p14:creationId xmlns:p14="http://schemas.microsoft.com/office/powerpoint/2010/main" val="13274019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18063" y="17988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25582" y="179885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76800" y="147635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518063" y="241075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25582" y="2410754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876800" y="2378504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518063" y="462402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25582" y="4624020"/>
            <a:ext cx="2095500" cy="2095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4876800" y="4591770"/>
            <a:ext cx="346988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173559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160</Words>
  <Application>Microsoft Office PowerPoint</Application>
  <PresentationFormat>On-screen Show (4:3)</PresentationFormat>
  <Paragraphs>56</Paragraphs>
  <Slides>3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5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zena</dc:creator>
  <cp:lastModifiedBy>Bozena</cp:lastModifiedBy>
  <cp:revision>12</cp:revision>
  <dcterms:created xsi:type="dcterms:W3CDTF">2006-08-16T00:00:00Z</dcterms:created>
  <dcterms:modified xsi:type="dcterms:W3CDTF">2019-08-27T06:21:41Z</dcterms:modified>
</cp:coreProperties>
</file>